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02" r:id="rId2"/>
  </p:sldIdLst>
  <p:sldSz cx="27432000" cy="20574000"/>
  <p:notesSz cx="6797675" cy="9928225"/>
  <p:defaultTextStyle>
    <a:defPPr>
      <a:defRPr lang="ko-KR"/>
    </a:defPPr>
    <a:lvl1pPr marL="0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1pPr>
    <a:lvl2pPr marL="1152144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2pPr>
    <a:lvl3pPr marL="2304288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3pPr>
    <a:lvl4pPr marL="3456432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4pPr>
    <a:lvl5pPr marL="4608576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5pPr>
    <a:lvl6pPr marL="5760720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6pPr>
    <a:lvl7pPr marL="6912864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7pPr>
    <a:lvl8pPr marL="8065008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8pPr>
    <a:lvl9pPr marL="9217152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80">
          <p15:clr>
            <a:srgbClr val="A4A3A4"/>
          </p15:clr>
        </p15:guide>
        <p15:guide id="2" pos="86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A9D18E"/>
    <a:srgbClr val="CC0000"/>
    <a:srgbClr val="F46363"/>
    <a:srgbClr val="FF6600"/>
    <a:srgbClr val="0000FF"/>
    <a:srgbClr val="E7E4E4"/>
    <a:srgbClr val="C0C0C0"/>
    <a:srgbClr val="EAEAEA"/>
    <a:srgbClr val="BDD7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647" autoAdjust="0"/>
    <p:restoredTop sz="94234" autoAdjust="0"/>
  </p:normalViewPr>
  <p:slideViewPr>
    <p:cSldViewPr snapToGrid="0">
      <p:cViewPr varScale="1">
        <p:scale>
          <a:sx n="34" d="100"/>
          <a:sy n="34" d="100"/>
        </p:scale>
        <p:origin x="858" y="90"/>
      </p:cViewPr>
      <p:guideLst>
        <p:guide orient="horz" pos="6480"/>
        <p:guide pos="86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5" d="100"/>
        <a:sy n="12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6" y="8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59" y="8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93480A-5757-4BB3-B00C-52279FD5DCC8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66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6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59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837069-2487-4C4A-82F4-FEAB95B0EA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2195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1pPr>
    <a:lvl2pPr marL="1152144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2pPr>
    <a:lvl3pPr marL="2304288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3pPr>
    <a:lvl4pPr marL="3456432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4pPr>
    <a:lvl5pPr marL="4608576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5pPr>
    <a:lvl6pPr marL="5760720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6pPr>
    <a:lvl7pPr marL="6912864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7pPr>
    <a:lvl8pPr marL="8065008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8pPr>
    <a:lvl9pPr marL="9217152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 altLang="ko-KR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2563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3337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314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509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8508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4384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009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162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939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6881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 altLang="ko-KR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4695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C7CFF-9D5D-476F-BE1D-251FECDD3324}" type="datetimeFigureOut">
              <a:rPr lang="ko-KR" altLang="en-US" smtClean="0"/>
              <a:t>2019-05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0567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3125844" y="1777411"/>
            <a:ext cx="21881949" cy="16042198"/>
            <a:chOff x="475987" y="1531667"/>
            <a:chExt cx="25963236" cy="1789611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10430" t="3048" b="1206"/>
            <a:stretch/>
          </p:blipFill>
          <p:spPr>
            <a:xfrm>
              <a:off x="2594143" y="1641994"/>
              <a:ext cx="23845080" cy="17754872"/>
            </a:xfrm>
            <a:prstGeom prst="rect">
              <a:avLst/>
            </a:prstGeom>
          </p:spPr>
        </p:pic>
        <p:grpSp>
          <p:nvGrpSpPr>
            <p:cNvPr id="11" name="Group 10"/>
            <p:cNvGrpSpPr/>
            <p:nvPr/>
          </p:nvGrpSpPr>
          <p:grpSpPr>
            <a:xfrm>
              <a:off x="501888" y="1531667"/>
              <a:ext cx="2014584" cy="1696051"/>
              <a:chOff x="605805" y="1766113"/>
              <a:chExt cx="2032892" cy="1766943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497571" y="3834618"/>
              <a:ext cx="2014584" cy="1696051"/>
              <a:chOff x="605805" y="1766113"/>
              <a:chExt cx="2032892" cy="1766943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493254" y="6162650"/>
              <a:ext cx="2014584" cy="1696051"/>
              <a:chOff x="605805" y="1766113"/>
              <a:chExt cx="2032892" cy="1766943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493254" y="8444696"/>
              <a:ext cx="2014584" cy="1696051"/>
              <a:chOff x="605805" y="1766113"/>
              <a:chExt cx="2032892" cy="1766943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488937" y="10772725"/>
              <a:ext cx="2014584" cy="1696051"/>
              <a:chOff x="605805" y="1766113"/>
              <a:chExt cx="2032892" cy="1766943"/>
            </a:xfrm>
          </p:grpSpPr>
          <p:sp>
            <p:nvSpPr>
              <p:cNvPr id="31" name="TextBox 30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484621" y="13100752"/>
              <a:ext cx="2014584" cy="1696051"/>
              <a:chOff x="605805" y="1766113"/>
              <a:chExt cx="2032892" cy="1766943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Group 41"/>
            <p:cNvGrpSpPr/>
            <p:nvPr/>
          </p:nvGrpSpPr>
          <p:grpSpPr>
            <a:xfrm>
              <a:off x="480304" y="15403707"/>
              <a:ext cx="2014584" cy="1696051"/>
              <a:chOff x="605805" y="1766113"/>
              <a:chExt cx="2032892" cy="1766943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" name="Group 47"/>
            <p:cNvGrpSpPr/>
            <p:nvPr/>
          </p:nvGrpSpPr>
          <p:grpSpPr>
            <a:xfrm>
              <a:off x="475987" y="17731732"/>
              <a:ext cx="2014584" cy="1696051"/>
              <a:chOff x="605805" y="1766113"/>
              <a:chExt cx="2032892" cy="1766943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709446" y="1766113"/>
                <a:ext cx="192925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742074" y="2105747"/>
                <a:ext cx="1896623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653271" y="2441029"/>
                <a:ext cx="1981071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605805" y="2732769"/>
                <a:ext cx="2032892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m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772264" y="3068051"/>
                <a:ext cx="1862076" cy="465005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altLang="ko-KR" sz="2000" b="1" spc="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DXS2  :</a:t>
                </a:r>
                <a:endParaRPr lang="ko-KR" altLang="en-US" sz="2000" b="1" spc="200" dirty="0" err="1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" name="Straight Connector 2"/>
          <p:cNvCxnSpPr/>
          <p:nvPr/>
        </p:nvCxnSpPr>
        <p:spPr>
          <a:xfrm>
            <a:off x="10371906" y="8494506"/>
            <a:ext cx="576000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1782693" y="8541643"/>
            <a:ext cx="3147849" cy="4616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PP binding domain</a:t>
            </a:r>
            <a:endParaRPr lang="ko-KR" altLang="en-US" sz="2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2814612" y="4542609"/>
            <a:ext cx="385042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4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0700223" y="10760431"/>
            <a:ext cx="385042" cy="70788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4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7842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>
          <a:defRPr b="1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700</TotalTime>
  <Words>85</Words>
  <Application>Microsoft Office PowerPoint</Application>
  <PresentationFormat>Custom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 min kyoung</dc:creator>
  <cp:lastModifiedBy>min kyoung You</cp:lastModifiedBy>
  <cp:revision>1241</cp:revision>
  <cp:lastPrinted>2018-06-12T07:02:34Z</cp:lastPrinted>
  <dcterms:created xsi:type="dcterms:W3CDTF">2016-01-08T01:55:13Z</dcterms:created>
  <dcterms:modified xsi:type="dcterms:W3CDTF">2019-05-10T07:47:52Z</dcterms:modified>
</cp:coreProperties>
</file>